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57" r:id="rId4"/>
    <p:sldId id="25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12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959877-E851-B3ED-85FA-F74F7C257CD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1D103C3-9884-ECB3-F80C-4E665142D62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732186-5874-C6C3-8D40-D77B2C2E6F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3B222-D0A7-41DE-8796-4EC37BCF8619}" type="datetimeFigureOut">
              <a:rPr lang="en-US" smtClean="0"/>
              <a:t>6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2C5BCA-25CE-A88C-C278-3A2EB354B2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AE7690-A313-8BBB-FC95-F9B3F4C924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7F027-09FB-447A-B7FF-CF6E75E90E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1703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9F5199-4D20-AD53-B9DC-BC34CDB40C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D7749D9-DDBB-40C8-4312-AFE311E37C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1AB8D7-2750-1B88-C408-59A9618968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3B222-D0A7-41DE-8796-4EC37BCF8619}" type="datetimeFigureOut">
              <a:rPr lang="en-US" smtClean="0"/>
              <a:t>6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872E68-6F15-9317-78F6-F7962F0BF6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FD4A60-E41D-EFDE-5B33-E908A6318B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7F027-09FB-447A-B7FF-CF6E75E90E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77080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3260A7E-9AA6-4068-4A06-4D0F636557E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37625EF-EB24-175A-6724-8B3AC90511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D47083-C74B-A081-ED91-AEDB5F19E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3B222-D0A7-41DE-8796-4EC37BCF8619}" type="datetimeFigureOut">
              <a:rPr lang="en-US" smtClean="0"/>
              <a:t>6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F412D5-3A01-6527-9496-FC9C938D81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D8F508-C841-0389-A89C-E733FC6638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7F027-09FB-447A-B7FF-CF6E75E90E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2991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FBCC6E-147B-4CCD-AC6D-72D5E8DAEC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FADA3D-4FB3-BD3E-09AF-CFE94AE3053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5C4F17-42EE-1419-9AA9-64D4FB47FD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3B222-D0A7-41DE-8796-4EC37BCF8619}" type="datetimeFigureOut">
              <a:rPr lang="en-US" smtClean="0"/>
              <a:t>6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82D737-28C3-8B35-D839-87D2D02E2C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9229A3-2316-AC74-883D-7A22AC0365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7F027-09FB-447A-B7FF-CF6E75E90E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5745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C19EE3-8DA6-D403-9304-B0A3A88C85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396DF2A-7313-5084-8661-F786AF0A10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51F081-B929-67B0-6B94-66DE7E2F0A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3B222-D0A7-41DE-8796-4EC37BCF8619}" type="datetimeFigureOut">
              <a:rPr lang="en-US" smtClean="0"/>
              <a:t>6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B1EDC1-2972-7067-25EF-30C872F3AB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4FA929-FE16-B71F-7D3E-BBAE9181FE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7F027-09FB-447A-B7FF-CF6E75E90E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18511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194A60-6A97-EB31-3128-BFE110A7AA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E442950-B1DD-B28C-5F10-C722B2BBB91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0746B19-22A9-8B6F-A6EE-AC1CAFD63B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B853A1-0910-CFE5-1FC5-4D8C95F7BA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3B222-D0A7-41DE-8796-4EC37BCF8619}" type="datetimeFigureOut">
              <a:rPr lang="en-US" smtClean="0"/>
              <a:t>6/1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AA92446-9008-DB05-F1E0-728196C877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AEDC17E-D487-8F49-DD3F-7B82F029BE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7F027-09FB-447A-B7FF-CF6E75E90E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34225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77F93C-B65D-6A3D-CCCD-2DFA9F904A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DDD6A72-CA48-9446-47BC-B409FB9016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FBEAF57-9EA5-CEAB-AA76-0F0C8C4DED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6772C86-AB74-79C2-5AD3-E9D65BD2D41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3740BCF-4924-8433-502D-706E17F31DE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9E3539-F119-9AA8-4E15-39FFF63837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3B222-D0A7-41DE-8796-4EC37BCF8619}" type="datetimeFigureOut">
              <a:rPr lang="en-US" smtClean="0"/>
              <a:t>6/17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04B78EA-D4D6-C623-7EA7-3A943F1D47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4B084AB-F78B-8BD8-72B9-7899D7BB8A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7F027-09FB-447A-B7FF-CF6E75E90E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28146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AB0D0B-8B30-DC80-3C76-29E948CD76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1057FCE-F4DC-F7D1-60D7-FADACE4B40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3B222-D0A7-41DE-8796-4EC37BCF8619}" type="datetimeFigureOut">
              <a:rPr lang="en-US" smtClean="0"/>
              <a:t>6/17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0BE534F-607A-A20C-5081-BCA0FAEE68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C54E0C6-9DF4-D099-36B4-D2C1D20381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7F027-09FB-447A-B7FF-CF6E75E90E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1674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D382135-DE84-C349-A6DB-194C52879B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3B222-D0A7-41DE-8796-4EC37BCF8619}" type="datetimeFigureOut">
              <a:rPr lang="en-US" smtClean="0"/>
              <a:t>6/17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2678871-CDBF-52D7-932E-BA7563DB2B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51C0FB0-9EE1-A7A6-1A40-18BD05B11F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7F027-09FB-447A-B7FF-CF6E75E90E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72534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DDD579-E4F7-609C-CCC2-E23506D919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8A435D-5A16-A2D6-6DE0-8AC6BDE0686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ECA22B8-C369-6470-5F36-5768DF9583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2FCBD0C-C961-64D8-2BE5-10CF9FF178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3B222-D0A7-41DE-8796-4EC37BCF8619}" type="datetimeFigureOut">
              <a:rPr lang="en-US" smtClean="0"/>
              <a:t>6/1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3F603C-C963-EA08-CC75-2A4344C19B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E21B38D-3C37-FD24-7BD4-6CD27EBEC9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7F027-09FB-447A-B7FF-CF6E75E90E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83328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A0CA5B-3B37-B0E1-3F2E-23B2EF50C3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515F809-46C7-6D48-686A-21DCD65AD7A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5B1E783-ED4D-C9F8-A721-7499DC7EB6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3B4151-AC13-A36B-8E85-85E95252DD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3B222-D0A7-41DE-8796-4EC37BCF8619}" type="datetimeFigureOut">
              <a:rPr lang="en-US" smtClean="0"/>
              <a:t>6/1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8E141E-FA94-6B4E-F08C-9F66CFF62D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B7D51EF-5C94-ABB7-146A-8DE63B1748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7F027-09FB-447A-B7FF-CF6E75E90E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71466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94E4CA6-A844-766E-9D1C-DD174BEABE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7CDC1DB-5A93-250A-273B-C6D6AFBE31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17BA0E-B6EE-5887-6447-E02A41FF713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13B222-D0A7-41DE-8796-4EC37BCF8619}" type="datetimeFigureOut">
              <a:rPr lang="en-US" smtClean="0"/>
              <a:t>6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E74399-A889-B105-B54B-342E2A9DF09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55128F-8C75-E0FD-FBCD-1BD65201E74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27F027-09FB-447A-B7FF-CF6E75E90E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4297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65D5027-B93B-22D8-5040-31B7C0BD716D}"/>
              </a:ext>
            </a:extLst>
          </p:cNvPr>
          <p:cNvPicPr>
            <a:picLocks noChangeAspect="1"/>
          </p:cNvPicPr>
          <p:nvPr/>
        </p:nvPicPr>
        <p:blipFill>
          <a:blip r:embed="rId2">
            <a:lum/>
          </a:blip>
          <a:stretch>
            <a:fillRect/>
          </a:stretch>
        </p:blipFill>
        <p:spPr>
          <a:xfrm>
            <a:off x="4586471" y="407407"/>
            <a:ext cx="2515884" cy="5715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74E5286-2329-547D-0026-1CE6D070B78E}"/>
              </a:ext>
            </a:extLst>
          </p:cNvPr>
          <p:cNvSpPr txBox="1"/>
          <p:nvPr/>
        </p:nvSpPr>
        <p:spPr>
          <a:xfrm>
            <a:off x="7650178" y="2719864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bri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EB20B1A-0C6E-0B1C-CC4C-156770AC0DA1}"/>
              </a:ext>
            </a:extLst>
          </p:cNvPr>
          <p:cNvSpPr txBox="1"/>
          <p:nvPr/>
        </p:nvSpPr>
        <p:spPr>
          <a:xfrm>
            <a:off x="7571128" y="4653394"/>
            <a:ext cx="21088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nonuclear cells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B843AC35-6A6D-2F9A-6EF4-297CE824323D}"/>
              </a:ext>
            </a:extLst>
          </p:cNvPr>
          <p:cNvCxnSpPr>
            <a:cxnSpLocks/>
          </p:cNvCxnSpPr>
          <p:nvPr/>
        </p:nvCxnSpPr>
        <p:spPr>
          <a:xfrm>
            <a:off x="6109653" y="2904530"/>
            <a:ext cx="1540525" cy="0"/>
          </a:xfrm>
          <a:prstGeom prst="straightConnector1">
            <a:avLst/>
          </a:prstGeom>
          <a:ln w="38100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2E3D42D2-EE9A-F8B1-4230-A0135F6C6030}"/>
              </a:ext>
            </a:extLst>
          </p:cNvPr>
          <p:cNvCxnSpPr>
            <a:cxnSpLocks/>
            <a:endCxn id="7" idx="1"/>
          </p:cNvCxnSpPr>
          <p:nvPr/>
        </p:nvCxnSpPr>
        <p:spPr>
          <a:xfrm>
            <a:off x="6109653" y="4838060"/>
            <a:ext cx="1461475" cy="0"/>
          </a:xfrm>
          <a:prstGeom prst="straightConnector1">
            <a:avLst/>
          </a:prstGeom>
          <a:ln w="38100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033563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925989-498B-48D2-C810-FC003EB1CE2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953789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Mononuclear cell isolation from brains of HIS-DRAGA and control mice.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rains were digested as indicated in the Materials and Methods section and subjected to Percoll gradient isolation. Shown here are the interphases containing mononuclear cells (lower) and debris (upper).</a:t>
            </a:r>
          </a:p>
          <a:p>
            <a:pPr marL="0" indent="0">
              <a:buNone/>
            </a:pPr>
            <a:endParaRPr 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44950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75347FF-5E20-BF07-7CF5-E306B19CF06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002" y="97247"/>
            <a:ext cx="7004911" cy="666350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51FC7B2-D821-D46F-A4E6-53E033E0D19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9798" r="698" b="15869"/>
          <a:stretch/>
        </p:blipFill>
        <p:spPr>
          <a:xfrm>
            <a:off x="7446399" y="2908824"/>
            <a:ext cx="4593599" cy="376708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54371C8-2A8F-1325-0BA1-B538CD80291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1584" t="37810" r="15828" b="12189"/>
          <a:stretch/>
        </p:blipFill>
        <p:spPr>
          <a:xfrm>
            <a:off x="7330920" y="296389"/>
            <a:ext cx="4786848" cy="2527594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FB55B09A-3636-60BE-AD42-410DFA939CF1}"/>
              </a:ext>
            </a:extLst>
          </p:cNvPr>
          <p:cNvSpPr/>
          <p:nvPr/>
        </p:nvSpPr>
        <p:spPr>
          <a:xfrm>
            <a:off x="1464733" y="4775200"/>
            <a:ext cx="550334" cy="414867"/>
          </a:xfrm>
          <a:prstGeom prst="rect">
            <a:avLst/>
          </a:prstGeom>
          <a:noFill/>
          <a:ln w="2222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C193D3C3-8AF2-233D-1E47-6AF4B3034EB6}"/>
              </a:ext>
            </a:extLst>
          </p:cNvPr>
          <p:cNvSpPr/>
          <p:nvPr/>
        </p:nvSpPr>
        <p:spPr>
          <a:xfrm>
            <a:off x="3012300" y="3429000"/>
            <a:ext cx="550334" cy="414867"/>
          </a:xfrm>
          <a:prstGeom prst="rect">
            <a:avLst/>
          </a:prstGeom>
          <a:noFill/>
          <a:ln w="2222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A816B20F-1402-DE06-CBB2-755FBC279C66}"/>
              </a:ext>
            </a:extLst>
          </p:cNvPr>
          <p:cNvCxnSpPr>
            <a:cxnSpLocks/>
          </p:cNvCxnSpPr>
          <p:nvPr/>
        </p:nvCxnSpPr>
        <p:spPr>
          <a:xfrm flipV="1">
            <a:off x="3562634" y="300447"/>
            <a:ext cx="3686578" cy="3128553"/>
          </a:xfrm>
          <a:prstGeom prst="straightConnector1">
            <a:avLst/>
          </a:prstGeom>
          <a:ln w="15875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B2137FCB-82B6-B0FB-1FB4-09F554A80A80}"/>
              </a:ext>
            </a:extLst>
          </p:cNvPr>
          <p:cNvCxnSpPr>
            <a:cxnSpLocks/>
          </p:cNvCxnSpPr>
          <p:nvPr/>
        </p:nvCxnSpPr>
        <p:spPr>
          <a:xfrm flipV="1">
            <a:off x="3574166" y="2828041"/>
            <a:ext cx="3752431" cy="1015826"/>
          </a:xfrm>
          <a:prstGeom prst="straightConnector1">
            <a:avLst/>
          </a:prstGeom>
          <a:ln w="15875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FDCE85AD-497D-EB87-0196-B6BAE7E3B783}"/>
              </a:ext>
            </a:extLst>
          </p:cNvPr>
          <p:cNvCxnSpPr>
            <a:cxnSpLocks/>
          </p:cNvCxnSpPr>
          <p:nvPr/>
        </p:nvCxnSpPr>
        <p:spPr>
          <a:xfrm flipV="1">
            <a:off x="2015067" y="2908824"/>
            <a:ext cx="5431332" cy="1887662"/>
          </a:xfrm>
          <a:prstGeom prst="straightConnector1">
            <a:avLst/>
          </a:prstGeom>
          <a:ln w="15875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3CB40E3C-A9EE-7ACB-11E6-6120A2D16BF8}"/>
              </a:ext>
            </a:extLst>
          </p:cNvPr>
          <p:cNvCxnSpPr>
            <a:cxnSpLocks/>
          </p:cNvCxnSpPr>
          <p:nvPr/>
        </p:nvCxnSpPr>
        <p:spPr>
          <a:xfrm>
            <a:off x="2038574" y="5196476"/>
            <a:ext cx="5407825" cy="1479436"/>
          </a:xfrm>
          <a:prstGeom prst="straightConnector1">
            <a:avLst/>
          </a:prstGeom>
          <a:ln w="15875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570032E3-EFB4-3986-EB0D-68A75DC02696}"/>
              </a:ext>
            </a:extLst>
          </p:cNvPr>
          <p:cNvCxnSpPr/>
          <p:nvPr/>
        </p:nvCxnSpPr>
        <p:spPr>
          <a:xfrm flipH="1">
            <a:off x="7799546" y="1364249"/>
            <a:ext cx="269798" cy="240387"/>
          </a:xfrm>
          <a:prstGeom prst="straightConnector1">
            <a:avLst/>
          </a:prstGeom>
          <a:ln w="22225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52BB14CE-1DD8-981A-F7E8-BF450B82555F}"/>
              </a:ext>
            </a:extLst>
          </p:cNvPr>
          <p:cNvCxnSpPr>
            <a:cxnSpLocks/>
          </p:cNvCxnSpPr>
          <p:nvPr/>
        </p:nvCxnSpPr>
        <p:spPr>
          <a:xfrm flipV="1">
            <a:off x="11359299" y="867266"/>
            <a:ext cx="301658" cy="188536"/>
          </a:xfrm>
          <a:prstGeom prst="straightConnector1">
            <a:avLst/>
          </a:prstGeom>
          <a:ln w="22225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6054243B-53DC-9600-7886-27BB10EE52DD}"/>
              </a:ext>
            </a:extLst>
          </p:cNvPr>
          <p:cNvCxnSpPr/>
          <p:nvPr/>
        </p:nvCxnSpPr>
        <p:spPr>
          <a:xfrm flipH="1">
            <a:off x="10600878" y="4382397"/>
            <a:ext cx="269798" cy="240387"/>
          </a:xfrm>
          <a:prstGeom prst="straightConnector1">
            <a:avLst/>
          </a:prstGeom>
          <a:ln w="22225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391618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D8DDE9-A570-D7D1-6870-61423872ED9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2540848"/>
            <a:ext cx="10515600" cy="1152965"/>
          </a:xfrm>
        </p:spPr>
        <p:txBody>
          <a:bodyPr/>
          <a:lstStyle/>
          <a:p>
            <a:pPr marL="0" indent="0">
              <a:buNone/>
            </a:pP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2. Visualization of microglia distribution in the whole brain of HIS-DRAGA mice.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rged images of brain section stained with DAPI (blue), anti-human TMEM119 (green), and anti-human CD45 (red). Shown are enlargements of two areas containing human microglia. </a:t>
            </a:r>
          </a:p>
          <a:p>
            <a:pPr marL="0" indent="0">
              <a:buNone/>
            </a:pP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8017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98</Words>
  <Application>Microsoft Office PowerPoint</Application>
  <PresentationFormat>Widescreen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sares, Sofia A CIV USN NMRC (USA)</dc:creator>
  <cp:lastModifiedBy>Ghosh Roy, Sounak CTR USN NMRC (IND)</cp:lastModifiedBy>
  <cp:revision>6</cp:revision>
  <dcterms:created xsi:type="dcterms:W3CDTF">2023-11-28T00:01:30Z</dcterms:created>
  <dcterms:modified xsi:type="dcterms:W3CDTF">2024-06-17T16:11:50Z</dcterms:modified>
</cp:coreProperties>
</file>